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9" r:id="rId3"/>
  </p:sldIdLst>
  <p:sldSz cx="6858000" cy="9906000" type="A4"/>
  <p:notesSz cx="6858000" cy="9144000"/>
  <p:custDataLst>
    <p:tags r:id="rId7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04" autoAdjust="0"/>
    <p:restoredTop sz="94660"/>
  </p:normalViewPr>
  <p:slideViewPr>
    <p:cSldViewPr snapToGrid="0" showGuides="1">
      <p:cViewPr varScale="1">
        <p:scale>
          <a:sx n="75" d="100"/>
          <a:sy n="75" d="100"/>
        </p:scale>
        <p:origin x="1608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 hasCustomPrompt="1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 hasCustomPrompt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 hasCustomPrompt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 hasCustomPrompt="1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 hasCustomPrompt="1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 hasCustomPrompt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  <a:endParaRPr lang="de-DE"/>
          </a:p>
          <a:p>
            <a:pPr lvl="1"/>
            <a:r>
              <a:rPr lang="de-DE"/>
              <a:t>Zweite Ebene</a:t>
            </a:r>
            <a:endParaRPr lang="de-DE"/>
          </a:p>
          <a:p>
            <a:pPr lvl="2"/>
            <a:r>
              <a:rPr lang="de-DE"/>
              <a:t>Dritte Ebene</a:t>
            </a:r>
            <a:endParaRPr lang="de-DE"/>
          </a:p>
          <a:p>
            <a:pPr lvl="3"/>
            <a:r>
              <a:rPr lang="de-DE"/>
              <a:t>Vierte Ebene</a:t>
            </a:r>
            <a:endParaRPr lang="de-DE"/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CBBE5B-8C57-4D53-874D-D2483BC2C3D0}" type="datetimeFigureOut">
              <a:rPr lang="en-US" smtClean="0"/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BB04C1-4670-40A5-AE28-C40C362DEED5}" type="slidenum">
              <a:rPr lang="en-US" smtClean="0"/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tissue_type_malignant_bubble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88900" y="680720"/>
            <a:ext cx="3240000" cy="1620000"/>
          </a:xfrm>
          <a:prstGeom prst="rect">
            <a:avLst/>
          </a:prstGeom>
        </p:spPr>
      </p:pic>
      <p:pic>
        <p:nvPicPr>
          <p:cNvPr id="3" name="图片 2" descr="tissue_type_CIS_bubble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93404" y="680720"/>
            <a:ext cx="3464596" cy="1620000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0" y="4222750"/>
            <a:ext cx="29654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0" y="442595"/>
            <a:ext cx="2603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altLang="zh-CN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319877" y="442595"/>
            <a:ext cx="2603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3319877" y="4222750"/>
            <a:ext cx="33845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0" y="6858000"/>
            <a:ext cx="6856604" cy="181483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4. Expression 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ene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ts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malignant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gression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in epithelial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on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SE181919 </a:t>
            </a:r>
            <a:r>
              <a:rPr lang="de-DE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dataset</a:t>
            </a:r>
            <a:r>
              <a:rPr lang="zh-CN" alt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ubble plo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show the expression of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dividual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genes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r>
              <a:rPr lang="en-US" altLang="de-DE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gene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A, C) and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24-gene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se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B, D) in all epithelial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B, C)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normal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issu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NL),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leukoplakia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LP) and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ancer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CA)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epithelial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EDY in different </a:t>
            </a:r>
            <a:r>
              <a:rPr lang="de-DE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tissues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C, D)</a:t>
            </a:r>
            <a:r>
              <a:rPr lang="zh-CN" alt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Violin plots show the score based on the 14-gene set (E) and based on the 24-gene set (F) for epithelial cells from cancers of males from the GSE181919 datase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. </a:t>
            </a:r>
            <a:r>
              <a:rPr lang="de-DE" altLang="zh-CN" sz="1400" dirty="0">
                <a:latin typeface="Arial" panose="020B0604020202020204" pitchFamily="34" charset="0"/>
                <a:cs typeface="Arial" panose="020B0604020202020204" pitchFamily="34" charset="0"/>
                <a:sym typeface="+mn-ea"/>
              </a:rPr>
              <a:t> * p&lt;=0.05, ** p&lt;=0.01, *** p&lt;=0.001 and **** p&lt;0.0001.</a:t>
            </a:r>
            <a:endParaRPr lang="de-DE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3" descr="tissue.edy_malignant_bubble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900" y="2496185"/>
            <a:ext cx="3240000" cy="1620000"/>
          </a:xfrm>
          <a:prstGeom prst="rect">
            <a:avLst/>
          </a:prstGeom>
        </p:spPr>
      </p:pic>
      <p:pic>
        <p:nvPicPr>
          <p:cNvPr id="13" name="图片 5" descr="tissue_EDY_CIS_bubble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93404" y="2520653"/>
            <a:ext cx="3463200" cy="1571065"/>
          </a:xfrm>
          <a:prstGeom prst="rect">
            <a:avLst/>
          </a:prstGeom>
        </p:spPr>
      </p:pic>
      <p:sp>
        <p:nvSpPr>
          <p:cNvPr id="14" name="文本框 5"/>
          <p:cNvSpPr txBox="1"/>
          <p:nvPr/>
        </p:nvSpPr>
        <p:spPr>
          <a:xfrm>
            <a:off x="0" y="2296795"/>
            <a:ext cx="2603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7"/>
          <p:cNvSpPr txBox="1"/>
          <p:nvPr/>
        </p:nvSpPr>
        <p:spPr>
          <a:xfrm>
            <a:off x="3319877" y="2296795"/>
            <a:ext cx="2603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altLang="zh-CN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 descr="CA_malignant_violin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6545" y="4445000"/>
            <a:ext cx="2179320" cy="2179320"/>
          </a:xfrm>
          <a:prstGeom prst="rect">
            <a:avLst/>
          </a:prstGeom>
        </p:spPr>
      </p:pic>
      <p:pic>
        <p:nvPicPr>
          <p:cNvPr id="16" name="图片 15" descr="CA_CIS_violin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80130" y="4441825"/>
            <a:ext cx="2172970" cy="217297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ZGQ2OGFkOTMxOTRjMjAwNGJjNzU4YzIzNGY2NWUwNzUifQ=="/>
</p:tagLst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613</Words>
  <Application>WPS 演示</Application>
  <PresentationFormat>A4-Papier (210 x 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微软雅黑</vt:lpstr>
      <vt:lpstr>Arial Unicode MS</vt:lpstr>
      <vt:lpstr>Calibri Light</vt:lpstr>
      <vt:lpstr>Calibri</vt:lpstr>
      <vt:lpstr>等线</vt:lpstr>
      <vt:lpstr>Offic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eß, Jochen</dc:creator>
  <cp:lastModifiedBy>韩蕊</cp:lastModifiedBy>
  <cp:revision>38</cp:revision>
  <dcterms:created xsi:type="dcterms:W3CDTF">2024-09-10T14:28:00Z</dcterms:created>
  <dcterms:modified xsi:type="dcterms:W3CDTF">2025-10-14T02:19:3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1ED59AF8EC64E509AB4233CA9FBF9A2_13</vt:lpwstr>
  </property>
  <property fmtid="{D5CDD505-2E9C-101B-9397-08002B2CF9AE}" pid="3" name="KSOProductBuildVer">
    <vt:lpwstr>2052-12.1.0.22529</vt:lpwstr>
  </property>
</Properties>
</file>